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08" y="-19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florenc\Desktop\Histology%20Data%20for%20Graphing%20-%20athero%20article%2020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Lesser Curvature Lesion Area (ORO)</a:t>
            </a:r>
          </a:p>
        </c:rich>
      </c:tx>
      <c:layout>
        <c:manualLayout>
          <c:xMode val="edge"/>
          <c:yMode val="edge"/>
          <c:x val="0.18594147953728007"/>
          <c:y val="1.3888888888888888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838424710800039"/>
          <c:y val="0.11158573928258968"/>
          <c:w val="0.80582336930105947"/>
          <c:h val="0.77243438320209978"/>
        </c:manualLayout>
      </c:layout>
      <c:barChart>
        <c:barDir val="col"/>
        <c:grouping val="clustered"/>
        <c:varyColors val="0"/>
        <c:ser>
          <c:idx val="6"/>
          <c:order val="6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7wk ORO Plaque Area'!$B$29:$E$29</c:f>
                <c:numCache>
                  <c:formatCode>General</c:formatCode>
                  <c:ptCount val="4"/>
                  <c:pt idx="0">
                    <c:v>2919.1395713605984</c:v>
                  </c:pt>
                  <c:pt idx="1">
                    <c:v>1084.9122471909602</c:v>
                  </c:pt>
                  <c:pt idx="2">
                    <c:v>298.26850925149921</c:v>
                  </c:pt>
                  <c:pt idx="3">
                    <c:v>536.5044527101129</c:v>
                  </c:pt>
                </c:numCache>
              </c:numRef>
            </c:plus>
            <c:minus>
              <c:numRef>
                <c:f>'7wk ORO Plaque Area'!$B$29:$E$29</c:f>
                <c:numCache>
                  <c:formatCode>General</c:formatCode>
                  <c:ptCount val="4"/>
                  <c:pt idx="0">
                    <c:v>2919.1395713605984</c:v>
                  </c:pt>
                  <c:pt idx="1">
                    <c:v>1084.9122471909602</c:v>
                  </c:pt>
                  <c:pt idx="2">
                    <c:v>298.26850925149921</c:v>
                  </c:pt>
                  <c:pt idx="3">
                    <c:v>536.5044527101129</c:v>
                  </c:pt>
                </c:numCache>
              </c:numRef>
            </c:minus>
          </c:errBars>
          <c:cat>
            <c:numRef>
              <c:f>'7wk ORO Plaque Area'!$B$19:$E$19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'7wk ORO Plaque Area'!$B$27:$E$27</c:f>
              <c:numCache>
                <c:formatCode>General</c:formatCode>
                <c:ptCount val="4"/>
                <c:pt idx="0">
                  <c:v>15128.766666666666</c:v>
                </c:pt>
                <c:pt idx="1">
                  <c:v>3444.9722222222222</c:v>
                </c:pt>
                <c:pt idx="2">
                  <c:v>4000.0833333333335</c:v>
                </c:pt>
                <c:pt idx="3">
                  <c:v>1708.1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760640"/>
        <c:axId val="129885312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7wk ORO Plaque Area'!$B$19,'7wk ORO Plaque Area'!$B$18,'7wk ORO Plaque Area'!$E$18,'7wk ORO Plaque Area'!$E$19)</c:f>
              <c:numCache>
                <c:formatCode>General</c:formatCode>
                <c:ptCount val="4"/>
                <c:pt idx="0">
                  <c:v>1</c:v>
                </c:pt>
                <c:pt idx="1">
                  <c:v>1.96</c:v>
                </c:pt>
                <c:pt idx="2">
                  <c:v>2.96</c:v>
                </c:pt>
                <c:pt idx="3">
                  <c:v>4</c:v>
                </c:pt>
              </c:numCache>
            </c:numRef>
          </c:xVal>
          <c:yVal>
            <c:numRef>
              <c:f>'7wk ORO Plaque Area'!$B$21:$E$21</c:f>
              <c:numCache>
                <c:formatCode>General</c:formatCode>
                <c:ptCount val="4"/>
                <c:pt idx="0">
                  <c:v>9965.6666666666661</c:v>
                </c:pt>
                <c:pt idx="1">
                  <c:v>4833.25</c:v>
                </c:pt>
                <c:pt idx="2">
                  <c:v>3641.2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7wk ORO Plaque Area'!$B$19,'7wk ORO Plaque Area'!$C$19,'7wk ORO Plaque Area'!$D$19,'7wk ORO Plaque Area'!$H$18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3.96</c:v>
                </c:pt>
              </c:numCache>
            </c:numRef>
          </c:xVal>
          <c:yVal>
            <c:numRef>
              <c:f>'7wk ORO Plaque Area'!$B$22:$E$22</c:f>
              <c:numCache>
                <c:formatCode>General</c:formatCode>
                <c:ptCount val="4"/>
                <c:pt idx="0">
                  <c:v>8434</c:v>
                </c:pt>
                <c:pt idx="3">
                  <c:v>2528.5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7wk ORO Plaque Area'!$B$19,'7wk ORO Plaque Area'!$C$18,'7wk ORO Plaque Area'!$D$19,'7wk ORO Plaque Area'!$E$19)</c:f>
              <c:numCache>
                <c:formatCode>General</c:formatCode>
                <c:ptCount val="4"/>
                <c:pt idx="0">
                  <c:v>1</c:v>
                </c:pt>
                <c:pt idx="1">
                  <c:v>2.04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7wk ORO Plaque Area'!$B$23:$E$23</c:f>
              <c:numCache>
                <c:formatCode>General</c:formatCode>
                <c:ptCount val="4"/>
                <c:pt idx="0">
                  <c:v>14995.666666666666</c:v>
                </c:pt>
                <c:pt idx="1">
                  <c:v>4195</c:v>
                </c:pt>
                <c:pt idx="2">
                  <c:v>4592.2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7wk ORO Plaque Area'!$B$19,'7wk ORO Plaque Area'!$C$19,'7wk ORO Plaque Area'!$F$18,'7wk ORO Plaque Area'!$I$18)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.04</c:v>
                </c:pt>
                <c:pt idx="3">
                  <c:v>4.04</c:v>
                </c:pt>
              </c:numCache>
            </c:numRef>
          </c:xVal>
          <c:yVal>
            <c:numRef>
              <c:f>'7wk ORO Plaque Area'!$B$24:$E$24</c:f>
              <c:numCache>
                <c:formatCode>General</c:formatCode>
                <c:ptCount val="4"/>
                <c:pt idx="0">
                  <c:v>24801.25</c:v>
                </c:pt>
                <c:pt idx="1">
                  <c:v>1306.6666666666667</c:v>
                </c:pt>
                <c:pt idx="2">
                  <c:v>3766.8</c:v>
                </c:pt>
                <c:pt idx="3">
                  <c:v>1897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7wk ORO Plaque Area'!$B$19:$E$19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7wk ORO Plaque Area'!$B$25:$E$25</c:f>
              <c:numCache>
                <c:formatCode>General</c:formatCode>
                <c:ptCount val="4"/>
                <c:pt idx="0">
                  <c:v>17447.25</c:v>
                </c:pt>
                <c:pt idx="3">
                  <c:v>699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7wk ORO Plaque Area'!$B$19:$E$19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7wk ORO Plaque Area'!$B$26:$E$26</c:f>
              <c:numCache>
                <c:formatCode>General</c:formatCode>
                <c:ptCount val="4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9760640"/>
        <c:axId val="129885312"/>
      </c:scatterChart>
      <c:catAx>
        <c:axId val="129760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9885312"/>
        <c:crosses val="autoZero"/>
        <c:auto val="1"/>
        <c:lblAlgn val="ctr"/>
        <c:lblOffset val="100"/>
        <c:noMultiLvlLbl val="0"/>
      </c:catAx>
      <c:valAx>
        <c:axId val="129885312"/>
        <c:scaling>
          <c:orientation val="minMax"/>
          <c:max val="400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sion Area (</a:t>
                </a:r>
                <a:r>
                  <a:rPr lang="el-G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²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424901574803149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29760640"/>
        <c:crosses val="autoZero"/>
        <c:crossBetween val="between"/>
        <c:majorUnit val="10000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nominate</a:t>
            </a:r>
            <a:r>
              <a:rPr lang="en-US" sz="14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Artery Lesion Area (ORO)</a:t>
            </a:r>
          </a:p>
        </c:rich>
      </c:tx>
      <c:layout>
        <c:manualLayout>
          <c:xMode val="edge"/>
          <c:yMode val="edge"/>
          <c:x val="0.19484567901234567"/>
          <c:y val="9.2592592592592587E-3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838424710800039"/>
          <c:y val="0.11158573928258968"/>
          <c:w val="0.7996505297948866"/>
          <c:h val="0.77243438320209978"/>
        </c:manualLayout>
      </c:layout>
      <c:barChart>
        <c:barDir val="col"/>
        <c:grouping val="clustered"/>
        <c:varyColors val="0"/>
        <c:ser>
          <c:idx val="6"/>
          <c:order val="6"/>
          <c:spPr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7wk ORO Plaque Area'!$B$13:$E$13</c:f>
                <c:numCache>
                  <c:formatCode>General</c:formatCode>
                  <c:ptCount val="4"/>
                  <c:pt idx="0">
                    <c:v>3909.7535432236646</c:v>
                  </c:pt>
                  <c:pt idx="1">
                    <c:v>3187.4347889190017</c:v>
                  </c:pt>
                  <c:pt idx="2">
                    <c:v>2664.6970178510815</c:v>
                  </c:pt>
                  <c:pt idx="3">
                    <c:v>3296.4788253276151</c:v>
                  </c:pt>
                </c:numCache>
              </c:numRef>
            </c:plus>
            <c:minus>
              <c:numRef>
                <c:f>'7wk ORO Plaque Area'!$B$13:$E$13</c:f>
                <c:numCache>
                  <c:formatCode>General</c:formatCode>
                  <c:ptCount val="4"/>
                  <c:pt idx="0">
                    <c:v>3909.7535432236646</c:v>
                  </c:pt>
                  <c:pt idx="1">
                    <c:v>3187.4347889190017</c:v>
                  </c:pt>
                  <c:pt idx="2">
                    <c:v>2664.6970178510815</c:v>
                  </c:pt>
                  <c:pt idx="3">
                    <c:v>3296.4788253276151</c:v>
                  </c:pt>
                </c:numCache>
              </c:numRef>
            </c:minus>
          </c:errBars>
          <c:cat>
            <c:numRef>
              <c:f>'7wk ORO Plaque Are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'7wk ORO Plaque Area'!$B$11:$E$11</c:f>
              <c:numCache>
                <c:formatCode>General</c:formatCode>
                <c:ptCount val="4"/>
                <c:pt idx="0">
                  <c:v>29225.5</c:v>
                </c:pt>
                <c:pt idx="1">
                  <c:v>15570.516666666668</c:v>
                </c:pt>
                <c:pt idx="2">
                  <c:v>7287.6166666666659</c:v>
                </c:pt>
                <c:pt idx="3">
                  <c:v>10056.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740224"/>
        <c:axId val="130741760"/>
      </c:barChar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7wk ORO Plaque Area'!$B$3,'7wk ORO Plaque Area'!$C$2,'7wk ORO Plaque Area'!$D$3,'7wk ORO Plaque Area'!$E$3)</c:f>
              <c:numCache>
                <c:formatCode>General</c:formatCode>
                <c:ptCount val="4"/>
                <c:pt idx="0">
                  <c:v>1</c:v>
                </c:pt>
                <c:pt idx="1">
                  <c:v>1.96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7wk ORO Plaque Area'!$B$5:$E$5</c:f>
              <c:numCache>
                <c:formatCode>General</c:formatCode>
                <c:ptCount val="4"/>
                <c:pt idx="0">
                  <c:v>35046</c:v>
                </c:pt>
                <c:pt idx="1">
                  <c:v>18474.75</c:v>
                </c:pt>
                <c:pt idx="2">
                  <c:v>6660.25</c:v>
                </c:pt>
              </c:numCache>
            </c:numRef>
          </c:yVal>
          <c:smooth val="0"/>
        </c:ser>
        <c:ser>
          <c:idx val="1"/>
          <c:order val="1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7wk ORO Plaque Are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7wk ORO Plaque Area'!$B$6:$E$6</c:f>
              <c:numCache>
                <c:formatCode>General</c:formatCode>
                <c:ptCount val="4"/>
                <c:pt idx="0">
                  <c:v>37297</c:v>
                </c:pt>
                <c:pt idx="3">
                  <c:v>8921.75</c:v>
                </c:pt>
              </c:numCache>
            </c:numRef>
          </c:yVal>
          <c:smooth val="0"/>
        </c:ser>
        <c:ser>
          <c:idx val="2"/>
          <c:order val="2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7wk ORO Plaque Are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7wk ORO Plaque Area'!$B$7:$E$7</c:f>
              <c:numCache>
                <c:formatCode>General</c:formatCode>
                <c:ptCount val="4"/>
                <c:pt idx="0">
                  <c:v>33882</c:v>
                </c:pt>
                <c:pt idx="1">
                  <c:v>9203.7999999999993</c:v>
                </c:pt>
                <c:pt idx="2">
                  <c:v>3018</c:v>
                </c:pt>
              </c:numCache>
            </c:numRef>
          </c:yVal>
          <c:smooth val="0"/>
        </c:ser>
        <c:ser>
          <c:idx val="3"/>
          <c:order val="3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('7wk ORO Plaque Area'!$B$3,'7wk ORO Plaque Area'!$D$2,'7wk ORO Plaque Area'!$D$3,'7wk ORO Plaque Area'!$E$3)</c:f>
              <c:numCache>
                <c:formatCode>General</c:formatCode>
                <c:ptCount val="4"/>
                <c:pt idx="0">
                  <c:v>1</c:v>
                </c:pt>
                <c:pt idx="1">
                  <c:v>2.04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7wk ORO Plaque Area'!$B$8:$E$8</c:f>
              <c:numCache>
                <c:formatCode>General</c:formatCode>
                <c:ptCount val="4"/>
                <c:pt idx="0">
                  <c:v>17402.75</c:v>
                </c:pt>
                <c:pt idx="1">
                  <c:v>19033</c:v>
                </c:pt>
                <c:pt idx="2">
                  <c:v>12184.6</c:v>
                </c:pt>
                <c:pt idx="3">
                  <c:v>4999</c:v>
                </c:pt>
              </c:numCache>
            </c:numRef>
          </c:yVal>
          <c:smooth val="0"/>
        </c:ser>
        <c:ser>
          <c:idx val="4"/>
          <c:order val="4"/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'7wk ORO Plaque Are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7wk ORO Plaque Area'!$B$9:$E$9</c:f>
              <c:numCache>
                <c:formatCode>General</c:formatCode>
                <c:ptCount val="4"/>
                <c:pt idx="0">
                  <c:v>22499.75</c:v>
                </c:pt>
                <c:pt idx="3">
                  <c:v>16248</c:v>
                </c:pt>
              </c:numCache>
            </c:numRef>
          </c:yVal>
          <c:smooth val="0"/>
        </c:ser>
        <c:ser>
          <c:idx val="5"/>
          <c:order val="5"/>
          <c:spPr>
            <a:ln w="28575">
              <a:noFill/>
            </a:ln>
          </c:spPr>
          <c:xVal>
            <c:numRef>
              <c:f>'7wk ORO Plaque Area'!$B$3:$E$3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xVal>
          <c:yVal>
            <c:numRef>
              <c:f>'7wk ORO Plaque Area'!$B$10:$E$10</c:f>
              <c:numCache>
                <c:formatCode>General</c:formatCode>
                <c:ptCount val="4"/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0740224"/>
        <c:axId val="130741760"/>
      </c:scatterChart>
      <c:catAx>
        <c:axId val="130740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30741760"/>
        <c:crosses val="autoZero"/>
        <c:auto val="1"/>
        <c:lblAlgn val="ctr"/>
        <c:lblOffset val="100"/>
        <c:noMultiLvlLbl val="0"/>
      </c:catAx>
      <c:valAx>
        <c:axId val="1307417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esion Area (</a:t>
                </a:r>
                <a:r>
                  <a:rPr lang="el-G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²</a:t>
                </a:r>
                <a:r>
                  <a:rPr lang="en-US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677449693788276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30740224"/>
        <c:crosses val="autoZero"/>
        <c:crossBetween val="between"/>
        <c:majorUnit val="10000"/>
      </c:valAx>
      <c:spPr>
        <a:solidFill>
          <a:schemeClr val="bg1">
            <a:lumMod val="95000"/>
          </a:schemeClr>
        </a:solidFill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2351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5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607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866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387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324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757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585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22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19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152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BEB7DF-57D6-4C7B-9B4F-0FBFA7D089C8}" type="datetimeFigureOut">
              <a:rPr lang="en-US" smtClean="0"/>
              <a:t>1/2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48B30-313E-4EE0-A581-4C05CE10A0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335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1046" y="152400"/>
            <a:ext cx="8229600" cy="838200"/>
          </a:xfrm>
        </p:spPr>
        <p:txBody>
          <a:bodyPr>
            <a:noAutofit/>
          </a:bodyPr>
          <a:lstStyle/>
          <a:p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ig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(Fig 1A -7wk ORO Staining)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228600" y="1855439"/>
            <a:ext cx="4800600" cy="2743200"/>
            <a:chOff x="304800" y="2209800"/>
            <a:chExt cx="4800600" cy="2743200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83664739"/>
                </p:ext>
              </p:extLst>
            </p:nvPr>
          </p:nvGraphicFramePr>
          <p:xfrm>
            <a:off x="304800" y="2209800"/>
            <a:ext cx="41148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838200" y="4641181"/>
              <a:ext cx="4267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WD + SHS       WD Only   Chow + SHS    Chow Only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4535055" y="1871694"/>
            <a:ext cx="4436097" cy="2743200"/>
            <a:chOff x="4724400" y="2209800"/>
            <a:chExt cx="4436097" cy="2743200"/>
          </a:xfrm>
        </p:grpSpPr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23329430"/>
                </p:ext>
              </p:extLst>
            </p:nvPr>
          </p:nvGraphicFramePr>
          <p:xfrm>
            <a:off x="4724400" y="2209800"/>
            <a:ext cx="41148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5274297" y="4611318"/>
              <a:ext cx="38862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WD + SHS      WD Only   Chow + SHS   Chow Only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246246" y="163345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80152" y="1633450"/>
            <a:ext cx="609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82549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1 Fig (Fig 1A -7wk ORO Staining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1 Figure (Fig 1A -7wk ORO Staining)</dc:title>
  <dc:creator>Florence, Jon</dc:creator>
  <cp:lastModifiedBy>Florence, Jon</cp:lastModifiedBy>
  <cp:revision>2</cp:revision>
  <dcterms:created xsi:type="dcterms:W3CDTF">2017-01-26T23:47:11Z</dcterms:created>
  <dcterms:modified xsi:type="dcterms:W3CDTF">2017-01-26T23:48:06Z</dcterms:modified>
</cp:coreProperties>
</file>